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E487E3-2225-4F4A-BE30-F12741987F0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E3A13F-8F31-4056-8A1E-4AFAEE1CF3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AF7DF2-C9A4-4AE5-9539-E312C1E36E3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A1B992-CD8D-452C-A080-A517293680B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909C3C-7BA8-49C0-A531-668099A65D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28A18E-C9C6-49A2-92C6-4FB733827B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DDC533-7E4F-4FCA-A8C1-9E14207D58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15D66E-5DAF-43C5-B983-EA14D2887C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DC9504-A510-4DF5-A5CB-6B21ED9E46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5B7D51-06A4-40C7-9EDE-2C78715CB8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23C526-CED9-4258-BD5F-435CDCA3A5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354D19-3FCE-4827-945C-A81718BE51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AD6755-E9E0-4651-A649-3794EFCCE46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590400" y="409680"/>
            <a:ext cx="8248680" cy="6134040"/>
            <a:chOff x="590400" y="409680"/>
            <a:chExt cx="8248680" cy="6134040"/>
          </a:xfrm>
        </p:grpSpPr>
        <p:sp>
          <p:nvSpPr>
            <p:cNvPr id="42" name="Rectangle 14"/>
            <p:cNvSpPr/>
            <p:nvPr/>
          </p:nvSpPr>
          <p:spPr>
            <a:xfrm>
              <a:off x="5931000" y="3871800"/>
              <a:ext cx="1647720" cy="2324160"/>
            </a:xfrm>
            <a:prstGeom prst="rect">
              <a:avLst/>
            </a:prstGeom>
            <a:solidFill>
              <a:srgbClr val="d9d9d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13"/>
            <p:cNvSpPr/>
            <p:nvPr/>
          </p:nvSpPr>
          <p:spPr>
            <a:xfrm>
              <a:off x="3381480" y="990720"/>
              <a:ext cx="2004840" cy="2324160"/>
            </a:xfrm>
            <a:prstGeom prst="rect">
              <a:avLst/>
            </a:prstGeom>
            <a:solidFill>
              <a:srgbClr val="d9d9d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6"/>
            <p:cNvSpPr/>
            <p:nvPr/>
          </p:nvSpPr>
          <p:spPr>
            <a:xfrm>
              <a:off x="704880" y="834480"/>
              <a:ext cx="7826400" cy="2615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ATCC11828(II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ATGCGCTGTGCGGTG</a:t>
              </a:r>
              <a:r>
                <a:rPr b="0" lang="en-US" sz="1200" spc="-1" strike="noStrike">
                  <a:solidFill>
                    <a:srgbClr val="ff0000"/>
                  </a:solidFill>
                  <a:latin typeface="Courier New"/>
                  <a:ea typeface="Times New Roman"/>
                </a:rPr>
                <a:t>G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TTGGCCATCCAG</a:t>
              </a:r>
              <a:r>
                <a:rPr b="0" lang="en-US" sz="1200" spc="-1" strike="noStrike">
                  <a:solidFill>
                    <a:srgbClr val="ff0000"/>
                  </a:solidFill>
                  <a:latin typeface="Courier New"/>
                  <a:ea typeface="Times New Roman"/>
                </a:rPr>
                <a:t>C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GGCTCACTCTTTGTCCCCGGCAATTCACCG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HL082PA2(II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ATGCGCTGTGCGGTG</a:t>
              </a:r>
              <a:r>
                <a:rPr b="0" lang="en-US" sz="1200" spc="-1" strike="noStrike">
                  <a:solidFill>
                    <a:srgbClr val="ff0000"/>
                  </a:solidFill>
                  <a:latin typeface="Courier New"/>
                  <a:ea typeface="Times New Roman"/>
                </a:rPr>
                <a:t>G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TTGGCCATCCAG</a:t>
              </a:r>
              <a:r>
                <a:rPr b="0" lang="en-US" sz="1200" spc="-1" strike="noStrike">
                  <a:solidFill>
                    <a:srgbClr val="ff0000"/>
                  </a:solidFill>
                  <a:latin typeface="Courier New"/>
                  <a:ea typeface="Times New Roman"/>
                </a:rPr>
                <a:t>C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GGCTCACTCTTTGTCCCCGGCAATTCACCG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HL110PA3(II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ATGCGCTGTGCGGTG</a:t>
              </a:r>
              <a:r>
                <a:rPr b="0" lang="en-US" sz="1200" spc="-1" strike="noStrike">
                  <a:solidFill>
                    <a:srgbClr val="ff0000"/>
                  </a:solidFill>
                  <a:latin typeface="Courier New"/>
                  <a:ea typeface="Times New Roman"/>
                </a:rPr>
                <a:t>G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TTGGCCATCCAG</a:t>
              </a:r>
              <a:r>
                <a:rPr b="0" lang="en-US" sz="1200" spc="-1" strike="noStrike">
                  <a:solidFill>
                    <a:srgbClr val="ff0000"/>
                  </a:solidFill>
                  <a:latin typeface="Courier New"/>
                  <a:ea typeface="Times New Roman"/>
                </a:rPr>
                <a:t>C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GGCTCACTCTTTGTCCCCGGCAATTCACCG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HL002PA2(IA</a:t>
              </a:r>
              <a:r>
                <a:rPr b="0" lang="en-US" sz="1200" spc="-1" strike="noStrike" baseline="-25000">
                  <a:solidFill>
                    <a:srgbClr val="000000"/>
                  </a:solidFill>
                  <a:latin typeface="Courier New"/>
                  <a:ea typeface="Times New Roman"/>
                </a:rPr>
                <a:t>1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ATGCGCTGTGCGGTGATTGGCCATCCAGTGGCTCACTCCTTGTCCCCGGCAATTCACCG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P.acn31(IA</a:t>
              </a:r>
              <a:r>
                <a:rPr b="0" lang="en-US" sz="1200" spc="-1" strike="noStrike" baseline="-25000">
                  <a:solidFill>
                    <a:srgbClr val="000000"/>
                  </a:solidFill>
                  <a:latin typeface="Courier New"/>
                  <a:ea typeface="Times New Roman"/>
                </a:rPr>
                <a:t>2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ATGCGCTGTGCGGTGATTGGCCATCCAGTGGCTCACTCCTTGTCCCCGGCAATTCACCG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Prp38(IC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ATGCGCTGTGCGGTGATTGGCCATCCAGTGGCTCACTCCTTGTCCCCGGCAATTCACCG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J165(IA</a:t>
              </a:r>
              <a:r>
                <a:rPr b="0" lang="en-US" sz="1200" spc="-1" strike="noStrike" baseline="-25000">
                  <a:solidFill>
                    <a:srgbClr val="000000"/>
                  </a:solidFill>
                  <a:latin typeface="Courier New"/>
                  <a:ea typeface="Times New Roman"/>
                </a:rPr>
                <a:t>1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ATGCGCTGTGCGGTGATTGGCCATCCAGTGGCTCACTCCTTGTCCCCGGCAATTCACCG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6609(IB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ATGCGCTGTGCGGTGATTGGCCATCCAGTGGCTCACTCCTTGTCCCCGGCAATTCACCG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SK182(IA</a:t>
              </a:r>
              <a:r>
                <a:rPr b="0" lang="en-US" sz="1200" spc="-1" strike="noStrike" baseline="-25000">
                  <a:solidFill>
                    <a:srgbClr val="000000"/>
                  </a:solidFill>
                  <a:latin typeface="Courier New"/>
                  <a:ea typeface="Times New Roman"/>
                </a:rPr>
                <a:t>1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ATGCGCTGTGCGGTGATTGGCCATCCAGTGGCTCACTCCTTGTCCCCGGCAATTCACCG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P.acn33(IA</a:t>
              </a:r>
              <a:r>
                <a:rPr b="0" lang="en-US" sz="1200" spc="-1" strike="noStrike" baseline="-25000">
                  <a:solidFill>
                    <a:srgbClr val="000000"/>
                  </a:solidFill>
                  <a:latin typeface="Courier New"/>
                  <a:ea typeface="Times New Roman"/>
                </a:rPr>
                <a:t>2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ATGCACTGTGCGGTGATTGGCCATCCAGTGGCTCACTCCTTGTCCCCGGCAATTCACCG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SK187(IA</a:t>
              </a:r>
              <a:r>
                <a:rPr b="0" lang="en-US" sz="1200" spc="-1" strike="noStrike" baseline="-25000">
                  <a:solidFill>
                    <a:srgbClr val="000000"/>
                  </a:solidFill>
                  <a:latin typeface="Courier New"/>
                  <a:ea typeface="Times New Roman"/>
                </a:rPr>
                <a:t>1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ATGCGCTGTGCGGTGATTGGCCATCCAGTGGCTCACTCCTTGTCCCCGGCAATTCACCG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12S(III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ATGCGCTGTGCGGTGGTTGGCCATCCAGTGGCTCACTCTTTGTCTCCGGCAATTCACCG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Asn12(III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ATGCGCTGTGCGGTGGTTGGCCATCCAGTGGCTCACTCTTTGTCTCCGGCAATTCACCG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tangle 9"/>
            <p:cNvSpPr/>
            <p:nvPr/>
          </p:nvSpPr>
          <p:spPr>
            <a:xfrm>
              <a:off x="692280" y="3719160"/>
              <a:ext cx="7867440" cy="2615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ATCC11828(II) 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GTGCAACTCATGACTGGCTACCCGGTGCCGATGGACGT</a:t>
              </a:r>
              <a:r>
                <a:rPr b="0" lang="en-US" sz="1200" spc="-1" strike="noStrike">
                  <a:solidFill>
                    <a:srgbClr val="ff0000"/>
                  </a:solidFill>
                  <a:latin typeface="Courier New"/>
                </a:rPr>
                <a:t>C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TTGAGGTCCACAGCGCAGAA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HL082PA2(II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GTGCAACTCATGACTGGCTACCCGGTGCCGATGGACGT</a:t>
              </a:r>
              <a:r>
                <a:rPr b="0" lang="en-US" sz="1200" spc="-1" strike="noStrike">
                  <a:solidFill>
                    <a:srgbClr val="ff0000"/>
                  </a:solidFill>
                  <a:latin typeface="Courier New"/>
                </a:rPr>
                <a:t>C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TTGAGGTCCACAGCGCAGAA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HL110PA3(II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GTGCAACTCATGACTGGCTACCCGGTGCCGATGGACGT</a:t>
              </a:r>
              <a:r>
                <a:rPr b="0" lang="en-US" sz="1200" spc="-1" strike="noStrike">
                  <a:solidFill>
                    <a:srgbClr val="ff0000"/>
                  </a:solidFill>
                  <a:latin typeface="Courier New"/>
                </a:rPr>
                <a:t>C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TTGAGGTCCACAGCGCAGAA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HL002PA2(IA</a:t>
              </a:r>
              <a:r>
                <a:rPr b="0" lang="en-US" sz="1200" spc="-1" strike="noStrike" baseline="-25000">
                  <a:solidFill>
                    <a:srgbClr val="000000"/>
                  </a:solidFill>
                  <a:latin typeface="Courier New"/>
                </a:rPr>
                <a:t>1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GTGCAACTCATGACTGGCTACCCGGTGCCGATGGACGTTTTGAGGTCCACAGCGCAGAA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P.acn31(IA</a:t>
              </a:r>
              <a:r>
                <a:rPr b="0" lang="en-US" sz="1200" spc="-1" strike="noStrike" baseline="-25000">
                  <a:solidFill>
                    <a:srgbClr val="000000"/>
                  </a:solidFill>
                  <a:latin typeface="Courier New"/>
                </a:rPr>
                <a:t>2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GTGCAACTCATGACTGGCTACCCGGTGCCGATGGACGTTTTGAGGTCCACAGCGCAGAA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Prp38(IC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GTGCAACTCATGACTGGCTACCCGGTGCCGATGGACGTTTTGAGGTCCACAGCGCAGAA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J165(IA</a:t>
              </a:r>
              <a:r>
                <a:rPr b="0" lang="en-US" sz="1200" spc="-1" strike="noStrike" baseline="-25000">
                  <a:solidFill>
                    <a:srgbClr val="000000"/>
                  </a:solidFill>
                  <a:latin typeface="Courier New"/>
                </a:rPr>
                <a:t>1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GTGCAACTCATGACTGGCTACCCGGTGCCGATGGACGTTTTGAGGTCCACAGCGCAGAA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6609(IB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GTGCAACTCATGACTGGCTACCCGGTGCCGATGGACGTTTTGAGGTCCACAGCGCAGAA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SK182(IA</a:t>
              </a:r>
              <a:r>
                <a:rPr b="0" lang="en-US" sz="1200" spc="-1" strike="noStrike" baseline="-25000">
                  <a:solidFill>
                    <a:srgbClr val="000000"/>
                  </a:solidFill>
                  <a:latin typeface="Courier New"/>
                </a:rPr>
                <a:t>1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GTGCAACTCATGACTGGCTACCCGGTGCCGATGGACGTTTTGAGGTCCACAGCGCAGAA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P.acn33(IA</a:t>
              </a:r>
              <a:r>
                <a:rPr b="0" lang="en-US" sz="1200" spc="-1" strike="noStrike" baseline="-25000">
                  <a:solidFill>
                    <a:srgbClr val="000000"/>
                  </a:solidFill>
                  <a:latin typeface="Courier New"/>
                </a:rPr>
                <a:t>2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GTGCAACTCATGACTGGCTACCCGGTGCCGATGGACGTTTTGAGGTCCACAGCGCAGAA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SK187(IA</a:t>
              </a:r>
              <a:r>
                <a:rPr b="0" lang="en-US" sz="1200" spc="-1" strike="noStrike" baseline="-25000">
                  <a:solidFill>
                    <a:srgbClr val="000000"/>
                  </a:solidFill>
                  <a:latin typeface="Courier New"/>
                </a:rPr>
                <a:t>1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GTGCAACTCATGACTGGCTACCCGGTGCCGATGGACGTTTTGAGGTCCACAGCGCAGAA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12S(III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GTGCAACTCATGACTGGCTACCCGGTGCCGATGGACGTTTTGAGGTCCACAGCGCAGAA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Asn12(III)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GTGCAACTCATGACTGGCTACCCGGTGCCGATGGACGTTTTGAGGTCCACAGCGCAGAA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10"/>
            <p:cNvSpPr/>
            <p:nvPr/>
          </p:nvSpPr>
          <p:spPr>
            <a:xfrm>
              <a:off x="3549600" y="584280"/>
              <a:ext cx="1706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Forward MLST primer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13"/>
            <p:cNvSpPr/>
            <p:nvPr/>
          </p:nvSpPr>
          <p:spPr>
            <a:xfrm>
              <a:off x="2598840" y="752400"/>
              <a:ext cx="46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4"/>
            <p:cNvSpPr/>
            <p:nvPr/>
          </p:nvSpPr>
          <p:spPr>
            <a:xfrm>
              <a:off x="7971480" y="77796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20"/>
            <p:cNvSpPr/>
            <p:nvPr/>
          </p:nvSpPr>
          <p:spPr>
            <a:xfrm>
              <a:off x="5907960" y="3435480"/>
              <a:ext cx="1715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Reverse MLST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rimer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ight Arrow 17"/>
            <p:cNvSpPr/>
            <p:nvPr/>
          </p:nvSpPr>
          <p:spPr>
            <a:xfrm>
              <a:off x="3368520" y="825480"/>
              <a:ext cx="2019600" cy="146160"/>
            </a:xfrm>
            <a:prstGeom prst="rightArrow">
              <a:avLst>
                <a:gd name="adj1" fmla="val 50000"/>
                <a:gd name="adj2" fmla="val 49961"/>
              </a:avLst>
            </a:prstGeom>
            <a:solidFill>
              <a:srgbClr val="bfbfb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640" bIns="266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ight Arrow 18"/>
            <p:cNvSpPr/>
            <p:nvPr/>
          </p:nvSpPr>
          <p:spPr>
            <a:xfrm rot="10800000">
              <a:off x="5909760" y="3691080"/>
              <a:ext cx="1667160" cy="155520"/>
            </a:xfrm>
            <a:prstGeom prst="rightArrow">
              <a:avLst>
                <a:gd name="adj1" fmla="val 50000"/>
                <a:gd name="adj2" fmla="val 50274"/>
              </a:avLst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5"/>
            <p:cNvSpPr/>
            <p:nvPr/>
          </p:nvSpPr>
          <p:spPr>
            <a:xfrm>
              <a:off x="590400" y="409680"/>
              <a:ext cx="8248680" cy="61340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14"/>
            <p:cNvSpPr/>
            <p:nvPr/>
          </p:nvSpPr>
          <p:spPr>
            <a:xfrm>
              <a:off x="2487240" y="362412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2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14"/>
            <p:cNvSpPr/>
            <p:nvPr/>
          </p:nvSpPr>
          <p:spPr>
            <a:xfrm>
              <a:off x="7922160" y="363708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18T13:58:10Z</dcterms:created>
  <dc:creator>Microbiology</dc:creator>
  <dc:description/>
  <dc:language>en-US</dc:language>
  <cp:lastModifiedBy>Dr Lorraine Martin</cp:lastModifiedBy>
  <dcterms:modified xsi:type="dcterms:W3CDTF">2013-04-23T16:03:56Z</dcterms:modified>
  <cp:revision>29</cp:revision>
  <dc:subject/>
  <dc:title>Slide 1</dc:title>
</cp:coreProperties>
</file>